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B55B38C-764E-4A22-9D5F-809569963FA4}" v="4" dt="2023-03-22T18:07:46.20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hnson, Eric T. - ARS" userId="5acbe24c-3fed-4a94-a6d2-eb3f4921ce84" providerId="ADAL" clId="{5B55B38C-764E-4A22-9D5F-809569963FA4}"/>
    <pc:docChg chg="modSld">
      <pc:chgData name="Johnson, Eric T. - ARS" userId="5acbe24c-3fed-4a94-a6d2-eb3f4921ce84" providerId="ADAL" clId="{5B55B38C-764E-4A22-9D5F-809569963FA4}" dt="2023-03-28T18:44:34.169" v="33" actId="1076"/>
      <pc:docMkLst>
        <pc:docMk/>
      </pc:docMkLst>
      <pc:sldChg chg="addSp modSp mod">
        <pc:chgData name="Johnson, Eric T. - ARS" userId="5acbe24c-3fed-4a94-a6d2-eb3f4921ce84" providerId="ADAL" clId="{5B55B38C-764E-4A22-9D5F-809569963FA4}" dt="2023-03-28T18:44:34.169" v="33" actId="1076"/>
        <pc:sldMkLst>
          <pc:docMk/>
          <pc:sldMk cId="900931670" sldId="256"/>
        </pc:sldMkLst>
        <pc:spChg chg="add mod">
          <ac:chgData name="Johnson, Eric T. - ARS" userId="5acbe24c-3fed-4a94-a6d2-eb3f4921ce84" providerId="ADAL" clId="{5B55B38C-764E-4A22-9D5F-809569963FA4}" dt="2023-03-28T18:44:34.169" v="33" actId="1076"/>
          <ac:spMkLst>
            <pc:docMk/>
            <pc:sldMk cId="900931670" sldId="256"/>
            <ac:spMk id="2" creationId="{A054167D-3599-4FF6-606C-48D7DB2712D9}"/>
          </ac:spMkLst>
        </pc:spChg>
      </pc:sldChg>
    </pc:docChg>
  </pc:docChgLst>
  <pc:docChgLst>
    <pc:chgData name="Johnson, Eric T. - ARS" userId="5acbe24c-3fed-4a94-a6d2-eb3f4921ce84" providerId="ADAL" clId="{A5273537-9FAB-4DFC-8E01-0C3EE888E8F9}"/>
    <pc:docChg chg="custSel modSld">
      <pc:chgData name="Johnson, Eric T. - ARS" userId="5acbe24c-3fed-4a94-a6d2-eb3f4921ce84" providerId="ADAL" clId="{A5273537-9FAB-4DFC-8E01-0C3EE888E8F9}" dt="2023-02-13T17:47:08.008" v="3" actId="962"/>
      <pc:docMkLst>
        <pc:docMk/>
      </pc:docMkLst>
      <pc:sldChg chg="addSp delSp modSp mod">
        <pc:chgData name="Johnson, Eric T. - ARS" userId="5acbe24c-3fed-4a94-a6d2-eb3f4921ce84" providerId="ADAL" clId="{A5273537-9FAB-4DFC-8E01-0C3EE888E8F9}" dt="2023-02-13T17:47:08.008" v="3" actId="962"/>
        <pc:sldMkLst>
          <pc:docMk/>
          <pc:sldMk cId="900931670" sldId="256"/>
        </pc:sldMkLst>
        <pc:picChg chg="add mod">
          <ac:chgData name="Johnson, Eric T. - ARS" userId="5acbe24c-3fed-4a94-a6d2-eb3f4921ce84" providerId="ADAL" clId="{A5273537-9FAB-4DFC-8E01-0C3EE888E8F9}" dt="2023-02-13T17:47:08.008" v="3" actId="962"/>
          <ac:picMkLst>
            <pc:docMk/>
            <pc:sldMk cId="900931670" sldId="256"/>
            <ac:picMk id="3" creationId="{1D9115AE-1E95-2FC8-5866-E1224499A9B8}"/>
          </ac:picMkLst>
        </pc:picChg>
        <pc:picChg chg="del">
          <ac:chgData name="Johnson, Eric T. - ARS" userId="5acbe24c-3fed-4a94-a6d2-eb3f4921ce84" providerId="ADAL" clId="{A5273537-9FAB-4DFC-8E01-0C3EE888E8F9}" dt="2023-02-13T17:46:11.003" v="0" actId="21"/>
          <ac:picMkLst>
            <pc:docMk/>
            <pc:sldMk cId="900931670" sldId="256"/>
            <ac:picMk id="5" creationId="{A42E70ED-2535-471E-B8C1-4D843BF2761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726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401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21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491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228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803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801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020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062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701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300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D8E2CB-1B04-4602-8D68-CF3A31669BC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EB311C-3A15-4384-9C14-55CE606871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379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1D9115AE-1E95-2FC8-5866-E1224499A9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4044"/>
            <a:ext cx="6858000" cy="897591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054167D-3599-4FF6-606C-48D7DB2712D9}"/>
              </a:ext>
            </a:extLst>
          </p:cNvPr>
          <p:cNvSpPr txBox="1"/>
          <p:nvPr/>
        </p:nvSpPr>
        <p:spPr>
          <a:xfrm>
            <a:off x="772842" y="1205948"/>
            <a:ext cx="2965427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4. Maximum likelihood </a:t>
            </a:r>
          </a:p>
          <a:p>
            <a:r>
              <a:rPr lang="en-US" sz="1200" dirty="0"/>
              <a:t>tree reconstructed from partial actin</a:t>
            </a:r>
          </a:p>
          <a:p>
            <a:r>
              <a:rPr lang="en-US" sz="1200" dirty="0"/>
              <a:t>gene sequences of </a:t>
            </a:r>
            <a:r>
              <a:rPr lang="en-US" sz="1200" i="1" dirty="0"/>
              <a:t>Cladosporium </a:t>
            </a:r>
          </a:p>
          <a:p>
            <a:r>
              <a:rPr lang="en-US" sz="1200" dirty="0"/>
              <a:t>species. Bootstrap values were </a:t>
            </a:r>
          </a:p>
          <a:p>
            <a:r>
              <a:rPr lang="en-US" sz="1200" dirty="0"/>
              <a:t>based on 500 </a:t>
            </a:r>
            <a:r>
              <a:rPr lang="en-US" sz="1200" dirty="0" err="1"/>
              <a:t>pseudoreplicates</a:t>
            </a:r>
            <a:r>
              <a:rPr lang="en-US" sz="1200" dirty="0"/>
              <a:t> as </a:t>
            </a:r>
          </a:p>
          <a:p>
            <a:r>
              <a:rPr lang="en-US" sz="1200" dirty="0"/>
              <a:t>indicated on branch points. The </a:t>
            </a:r>
          </a:p>
          <a:p>
            <a:r>
              <a:rPr lang="en-US" sz="1200" i="1" dirty="0" err="1"/>
              <a:t>Cercospora</a:t>
            </a:r>
            <a:r>
              <a:rPr lang="en-US" sz="1200" i="1" dirty="0"/>
              <a:t> </a:t>
            </a:r>
            <a:r>
              <a:rPr lang="en-US" sz="1200" i="1" dirty="0" err="1"/>
              <a:t>beticola</a:t>
            </a:r>
            <a:r>
              <a:rPr lang="en-US" sz="1200" i="1" dirty="0"/>
              <a:t> </a:t>
            </a:r>
            <a:r>
              <a:rPr lang="en-US" sz="1200" dirty="0"/>
              <a:t>actin gene </a:t>
            </a:r>
          </a:p>
          <a:p>
            <a:r>
              <a:rPr lang="en-US" sz="1200" dirty="0"/>
              <a:t>was used as an outgroup. The scale </a:t>
            </a:r>
          </a:p>
          <a:p>
            <a:r>
              <a:rPr lang="en-US" sz="1200" dirty="0"/>
              <a:t>bar corresponds to 0.10 nucleotide </a:t>
            </a:r>
          </a:p>
          <a:p>
            <a:r>
              <a:rPr lang="en-US" sz="1200" dirty="0"/>
              <a:t>substitutions per site. T means ex-type </a:t>
            </a:r>
          </a:p>
          <a:p>
            <a:r>
              <a:rPr lang="en-US" sz="1200" dirty="0"/>
              <a:t>train. ET means ex-</a:t>
            </a:r>
            <a:r>
              <a:rPr lang="en-US" sz="1200" dirty="0" err="1"/>
              <a:t>epitype</a:t>
            </a:r>
            <a:r>
              <a:rPr lang="en-US" sz="1200" dirty="0"/>
              <a:t> strain.</a:t>
            </a:r>
          </a:p>
        </p:txBody>
      </p:sp>
    </p:spTree>
    <p:extLst>
      <p:ext uri="{BB962C8B-B14F-4D97-AF65-F5344CB8AC3E}">
        <p14:creationId xmlns:p14="http://schemas.microsoft.com/office/powerpoint/2010/main" val="900931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62</Words>
  <Application>Microsoft Office PowerPoint</Application>
  <PresentationFormat>Letter Paper (8.5x11 in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Eric T. - ARS</dc:creator>
  <cp:lastModifiedBy>Johnson, Eric T. - ARS</cp:lastModifiedBy>
  <cp:revision>1</cp:revision>
  <dcterms:created xsi:type="dcterms:W3CDTF">2022-11-29T18:18:47Z</dcterms:created>
  <dcterms:modified xsi:type="dcterms:W3CDTF">2023-03-28T18:44:44Z</dcterms:modified>
</cp:coreProperties>
</file>